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110241-AAE8-450E-9651-6D777E2D9FE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dditional Fil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E68D4D-A317-47D4-9484-4E9D27464EB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86714-C6ED-4965-9DC2-1F58A5AFAE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34FC0-3F23-41AE-B9C8-31E85AA3CF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748CC-2569-4734-A43C-92A2DB55BF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9E901-A10D-41B3-BFED-1D588B02C3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56412-6EBB-40F6-B2B8-72C10448CD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DE68E-40F3-4325-A5D0-C5646B3915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85477-0E61-4BE9-9922-324058696C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6E844-AF9F-4551-8995-A29A8292F1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A154A-C96D-4403-9F33-01E23107A6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2A3A0-0109-423A-BF6D-4DAE985281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154C0-C588-4F5F-9C3F-A8300C1671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4CE906-804F-4102-A4E6-382F4210B9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EF5201-5CBB-43AA-AA3F-E5D58E313B8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K:\Maria Libera\Collaborations\Collaboration with Masoud breast samples\BRB  ANALYSIS\innate response\natural killer signalin 3.jpg"/>
          <p:cNvPicPr/>
          <p:nvPr/>
        </p:nvPicPr>
        <p:blipFill>
          <a:blip r:embed="rId1"/>
          <a:srcRect l="0" t="20751" r="1591" b="10085"/>
          <a:stretch/>
        </p:blipFill>
        <p:spPr>
          <a:xfrm>
            <a:off x="304920" y="914400"/>
            <a:ext cx="8686800" cy="5164200"/>
          </a:xfrm>
          <a:prstGeom prst="rect">
            <a:avLst/>
          </a:prstGeom>
          <a:ln w="0">
            <a:noFill/>
          </a:ln>
        </p:spPr>
      </p:pic>
      <p:sp>
        <p:nvSpPr>
          <p:cNvPr id="49" name="TextBox 2"/>
          <p:cNvSpPr/>
          <p:nvPr/>
        </p:nvSpPr>
        <p:spPr>
          <a:xfrm>
            <a:off x="1795320" y="1092240"/>
            <a:ext cx="53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LCK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Fyn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"/>
          <p:cNvSpPr/>
          <p:nvPr/>
        </p:nvSpPr>
        <p:spPr>
          <a:xfrm>
            <a:off x="0" y="1100160"/>
            <a:ext cx="515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NK cell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4"/>
          <p:cNvSpPr/>
          <p:nvPr/>
        </p:nvSpPr>
        <p:spPr>
          <a:xfrm>
            <a:off x="0" y="981000"/>
            <a:ext cx="304920" cy="46080"/>
          </a:xfrm>
          <a:prstGeom prst="rect">
            <a:avLst/>
          </a:prstGeom>
          <a:solidFill>
            <a:srgbClr val="7f7f7f">
              <a:alpha val="85000"/>
            </a:srgbClr>
          </a:solidFill>
          <a:ln w="25560">
            <a:solidFill>
              <a:srgbClr val="7f7f7f">
                <a:alpha val="7200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" name="Group 9"/>
          <p:cNvGrpSpPr/>
          <p:nvPr/>
        </p:nvGrpSpPr>
        <p:grpSpPr>
          <a:xfrm>
            <a:off x="25560" y="4826160"/>
            <a:ext cx="2265120" cy="2019600"/>
            <a:chOff x="25560" y="4826160"/>
            <a:chExt cx="2265120" cy="2019600"/>
          </a:xfrm>
        </p:grpSpPr>
        <p:pic>
          <p:nvPicPr>
            <p:cNvPr id="53" name="Picture 2" descr="An external file that holds a picture, illustration, etc.&#10;Object name is 1471-2164-10-301-6.jpg Object name is 1471-2164-10-301-6.jpg"/>
            <p:cNvPicPr/>
            <p:nvPr/>
          </p:nvPicPr>
          <p:blipFill>
            <a:blip r:embed="rId2"/>
            <a:srcRect l="2675" t="50571" r="92762" b="0"/>
            <a:stretch/>
          </p:blipFill>
          <p:spPr>
            <a:xfrm>
              <a:off x="25560" y="5045040"/>
              <a:ext cx="335160" cy="180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6"/>
            <p:cNvSpPr/>
            <p:nvPr/>
          </p:nvSpPr>
          <p:spPr>
            <a:xfrm>
              <a:off x="379440" y="4991760"/>
              <a:ext cx="1911240" cy="1798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emical or Drug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kin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zym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-protein Coupled Recep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roup or Comple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rowth Fac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Ion Channel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Kinas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gand-dependent Nuclear Recep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ptidas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sphatase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cription Regula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lation Regula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membrane Recep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porte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he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7"/>
            <p:cNvSpPr/>
            <p:nvPr/>
          </p:nvSpPr>
          <p:spPr>
            <a:xfrm>
              <a:off x="75600" y="4826160"/>
              <a:ext cx="205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gen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8"/>
            <p:cNvSpPr/>
            <p:nvPr/>
          </p:nvSpPr>
          <p:spPr>
            <a:xfrm>
              <a:off x="47160" y="4850280"/>
              <a:ext cx="2031120" cy="1956600"/>
            </a:xfrm>
            <a:prstGeom prst="rect">
              <a:avLst/>
            </a:prstGeom>
            <a:noFill/>
            <a:ln w="25560">
              <a:solidFill>
                <a:srgbClr val="bfbfbf">
                  <a:alpha val="65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3T18:40:09Z</dcterms:created>
  <dc:creator>asciertoml</dc:creator>
  <dc:description/>
  <dc:language>en-US</dc:language>
  <cp:lastModifiedBy>asciertoml</cp:lastModifiedBy>
  <dcterms:modified xsi:type="dcterms:W3CDTF">2011-11-30T18:22:45Z</dcterms:modified>
  <cp:revision>311</cp:revision>
  <dc:subject/>
  <dc:title>Slide 1</dc:title>
</cp:coreProperties>
</file>